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0" r:id="rId2"/>
  </p:sldIdLst>
  <p:sldSz cx="9144000" cy="6858000" type="screen4x3"/>
  <p:notesSz cx="7010400" cy="92233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Untitled Section" id="{79AA27B0-A9E3-4853-8367-98DDA2B9F2D0}">
          <p14:sldIdLst>
            <p14:sldId id="290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lzan, Heba Fathy" initials="AHF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745" autoAdjust="0"/>
    <p:restoredTop sz="94512" autoAdjust="0"/>
  </p:normalViewPr>
  <p:slideViewPr>
    <p:cSldViewPr>
      <p:cViewPr varScale="1">
        <p:scale>
          <a:sx n="74" d="100"/>
          <a:sy n="74" d="100"/>
        </p:scale>
        <p:origin x="1134" y="5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Chart%20in%20Microsoft%20PowerPoint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4"/>
    </mc:Choice>
    <mc:Fallback>
      <c:style val="4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600" b="0"/>
            </a:pPr>
            <a:r>
              <a:rPr lang="en-US" sz="1600" b="0" i="1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600" b="0">
                <a:latin typeface="Arial" panose="020B0604020202020204" pitchFamily="34" charset="0"/>
                <a:cs typeface="Arial" panose="020B0604020202020204" pitchFamily="34" charset="0"/>
              </a:rPr>
              <a:t> = 0.4</a:t>
            </a:r>
          </a:p>
        </c:rich>
      </c:tx>
      <c:layout>
        <c:manualLayout>
          <c:xMode val="edge"/>
          <c:yMode val="edge"/>
          <c:x val="0.5240083177889111"/>
          <c:y val="6.5412055384120982E-2"/>
        </c:manualLayout>
      </c:layout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Larva new'!$L$18:$M$18</c:f>
                <c:numCache>
                  <c:formatCode>General</c:formatCode>
                  <c:ptCount val="2"/>
                  <c:pt idx="0">
                    <c:v>288.91306190701101</c:v>
                  </c:pt>
                  <c:pt idx="1">
                    <c:v>34.87792183847589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Larva new'!$L$16:$M$16</c:f>
              <c:strCache>
                <c:ptCount val="2"/>
                <c:pt idx="0">
                  <c:v>Vaccinated not induced</c:v>
                </c:pt>
                <c:pt idx="1">
                  <c:v>Control not induced</c:v>
                </c:pt>
              </c:strCache>
            </c:strRef>
          </c:cat>
          <c:val>
            <c:numRef>
              <c:f>'Larva new'!$L$17:$M$17</c:f>
              <c:numCache>
                <c:formatCode>General</c:formatCode>
                <c:ptCount val="2"/>
                <c:pt idx="0">
                  <c:v>189.84637500000005</c:v>
                </c:pt>
                <c:pt idx="1">
                  <c:v>22.79291666666666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F56-9B46-B909-5174B913A2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51103520"/>
        <c:axId val="751115488"/>
      </c:barChart>
      <c:catAx>
        <c:axId val="75110352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 b="0"/>
                </a:pPr>
                <a:r>
                  <a:rPr lang="en-US" sz="12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Tick Larvae</a:t>
                </a: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751115488"/>
        <c:crosses val="autoZero"/>
        <c:auto val="1"/>
        <c:lblAlgn val="ctr"/>
        <c:lblOffset val="100"/>
        <c:noMultiLvlLbl val="0"/>
      </c:catAx>
      <c:valAx>
        <c:axId val="751115488"/>
        <c:scaling>
          <c:logBase val="10"/>
          <c:orientation val="minMax"/>
          <c:min val="1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/>
                </a:pPr>
                <a:r>
                  <a:rPr lang="en-US" sz="1200" b="0" i="0" baseline="0" dirty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Log square mean</a:t>
                </a:r>
                <a:endParaRPr lang="en-US" sz="1200" b="0" dirty="0"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751103520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7"/>
    </mc:Choice>
    <mc:Fallback>
      <c:style val="7"/>
    </mc:Fallback>
  </mc:AlternateContent>
  <c:chart>
    <c:title>
      <c:tx>
        <c:rich>
          <a:bodyPr/>
          <a:lstStyle/>
          <a:p>
            <a:pPr>
              <a:defRPr sz="1600" b="0"/>
            </a:pPr>
            <a:r>
              <a:rPr lang="en-US" sz="1600" b="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600" b="0" dirty="0">
                <a:latin typeface="Arial" panose="020B0604020202020204" pitchFamily="34" charset="0"/>
                <a:cs typeface="Arial" panose="020B0604020202020204" pitchFamily="34" charset="0"/>
              </a:rPr>
              <a:t> = 0.9</a:t>
            </a:r>
          </a:p>
        </c:rich>
      </c:tx>
      <c:layout>
        <c:manualLayout>
          <c:xMode val="edge"/>
          <c:yMode val="edge"/>
          <c:x val="0.52463003770971939"/>
          <c:y val="2.6121491572926422E-2"/>
        </c:manualLayout>
      </c:layout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Larva new'!$Y$37:$Z$37</c:f>
                <c:numCache>
                  <c:formatCode>General</c:formatCode>
                  <c:ptCount val="2"/>
                  <c:pt idx="0">
                    <c:v>3046.4226461399776</c:v>
                  </c:pt>
                  <c:pt idx="1">
                    <c:v>2622.74798023999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Larva new'!$Y$35:$Z$35</c:f>
              <c:strCache>
                <c:ptCount val="2"/>
                <c:pt idx="0">
                  <c:v>Vaccinated induced </c:v>
                </c:pt>
                <c:pt idx="1">
                  <c:v>Control induced</c:v>
                </c:pt>
              </c:strCache>
            </c:strRef>
          </c:cat>
          <c:val>
            <c:numRef>
              <c:f>'Larva new'!$Y$36:$Z$36</c:f>
              <c:numCache>
                <c:formatCode>General</c:formatCode>
                <c:ptCount val="2"/>
                <c:pt idx="0">
                  <c:v>1887.433033333333</c:v>
                </c:pt>
                <c:pt idx="1">
                  <c:v>1534.908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224-BE48-A44A-CBB0D63E26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51106240"/>
        <c:axId val="751104064"/>
      </c:barChart>
      <c:catAx>
        <c:axId val="75110624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 b="0"/>
                </a:pPr>
                <a:r>
                  <a:rPr lang="en-US" sz="1200" b="0" i="0" baseline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Tick Larvae</a:t>
                </a:r>
                <a:endParaRPr lang="en-US" sz="1200" b="0" dirty="0"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751104064"/>
        <c:crosses val="autoZero"/>
        <c:auto val="1"/>
        <c:lblAlgn val="ctr"/>
        <c:lblOffset val="100"/>
        <c:noMultiLvlLbl val="0"/>
      </c:catAx>
      <c:valAx>
        <c:axId val="751104064"/>
        <c:scaling>
          <c:logBase val="10"/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/>
                </a:pPr>
                <a:r>
                  <a:rPr lang="en-US" sz="1200" b="0" i="0" baseline="0" dirty="0"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Log square mean</a:t>
                </a:r>
                <a:endParaRPr lang="en-US" sz="1200" b="0" dirty="0"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75110624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/>
            </a:pPr>
            <a:r>
              <a:rPr lang="en-US" sz="1600" b="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600" b="0" dirty="0">
                <a:latin typeface="Arial" panose="020B0604020202020204" pitchFamily="34" charset="0"/>
                <a:cs typeface="Arial" panose="020B0604020202020204" pitchFamily="34" charset="0"/>
              </a:rPr>
              <a:t> = 1</a:t>
            </a:r>
          </a:p>
        </c:rich>
      </c:tx>
      <c:layout>
        <c:manualLayout>
          <c:xMode val="edge"/>
          <c:yMode val="edge"/>
          <c:x val="0.51236085244057128"/>
          <c:y val="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21776631998904936"/>
          <c:y val="3.7488394296700957E-2"/>
          <c:w val="0.75445584851135761"/>
          <c:h val="0.66187992603547829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[Chart in Microsoft PowerPoint]Egg data'!$F$12,'[Chart in Microsoft PowerPoint]Egg data'!$I$12</c:f>
                <c:numCache>
                  <c:formatCode>General</c:formatCode>
                  <c:ptCount val="2"/>
                  <c:pt idx="0">
                    <c:v>2.6953840252055636</c:v>
                  </c:pt>
                  <c:pt idx="1">
                    <c:v>2.96166167941804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Chart in Microsoft PowerPoint]Egg data'!$H$16:$I$16</c:f>
              <c:strCache>
                <c:ptCount val="2"/>
                <c:pt idx="0">
                  <c:v>Control</c:v>
                </c:pt>
                <c:pt idx="1">
                  <c:v>Vaccinated</c:v>
                </c:pt>
              </c:strCache>
            </c:strRef>
          </c:cat>
          <c:val>
            <c:numRef>
              <c:f>'[Chart in Microsoft PowerPoint]Egg data'!$H$17:$I$17</c:f>
              <c:numCache>
                <c:formatCode>General</c:formatCode>
                <c:ptCount val="2"/>
                <c:pt idx="0">
                  <c:v>75.382899999999992</c:v>
                </c:pt>
                <c:pt idx="1">
                  <c:v>75.5069000000000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D89-4B44-81C9-E2FD0F2933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51106784"/>
        <c:axId val="751113312"/>
      </c:barChart>
      <c:catAx>
        <c:axId val="75110678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 b="0"/>
                </a:pPr>
                <a:r>
                  <a:rPr lang="en-US" sz="1200" b="0">
                    <a:latin typeface="Arial" panose="020B0604020202020204" pitchFamily="34" charset="0"/>
                    <a:cs typeface="Arial" panose="020B0604020202020204" pitchFamily="34" charset="0"/>
                  </a:rPr>
                  <a:t>Egg source</a:t>
                </a:r>
              </a:p>
            </c:rich>
          </c:tx>
          <c:layout/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751113312"/>
        <c:crosses val="autoZero"/>
        <c:auto val="1"/>
        <c:lblAlgn val="ctr"/>
        <c:lblOffset val="100"/>
        <c:noMultiLvlLbl val="0"/>
      </c:catAx>
      <c:valAx>
        <c:axId val="751113312"/>
        <c:scaling>
          <c:orientation val="minMax"/>
          <c:max val="80"/>
          <c:min val="1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 b="0"/>
                </a:pPr>
                <a:r>
                  <a:rPr lang="en-US" sz="1200" b="0">
                    <a:latin typeface="Arial" panose="020B0604020202020204" pitchFamily="34" charset="0"/>
                    <a:cs typeface="Arial" panose="020B0604020202020204" pitchFamily="34" charset="0"/>
                  </a:rPr>
                  <a:t>Egg weight (mg)</a:t>
                </a:r>
              </a:p>
            </c:rich>
          </c:tx>
          <c:layout>
            <c:manualLayout>
              <c:xMode val="edge"/>
              <c:yMode val="edge"/>
              <c:x val="4.2777821829666177E-2"/>
              <c:y val="3.9139420455625455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75110678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600" b="0"/>
            </a:pPr>
            <a:r>
              <a:rPr lang="en-US" sz="1600" b="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600" b="0" dirty="0">
                <a:latin typeface="Arial" panose="020B0604020202020204" pitchFamily="34" charset="0"/>
                <a:cs typeface="Arial" panose="020B0604020202020204" pitchFamily="34" charset="0"/>
              </a:rPr>
              <a:t> = 0.32</a:t>
            </a:r>
          </a:p>
        </c:rich>
      </c:tx>
      <c:layout>
        <c:manualLayout>
          <c:xMode val="edge"/>
          <c:yMode val="edge"/>
          <c:x val="0.4591644366741211"/>
          <c:y val="8.2849850880241979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21261246393385941"/>
          <c:y val="0.10556130731174328"/>
          <c:w val="0.75736778577803043"/>
          <c:h val="0.604135235655363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[Copy of 6-CYS Vaccine Expt Heba spreadsheet 6-22-16 eggs.xlsx]Egg data'!$D$34</c:f>
              <c:strCache>
                <c:ptCount val="1"/>
                <c:pt idx="0">
                  <c:v>Tick weight (gm)</c:v>
                </c:pt>
              </c:strCache>
            </c:strRef>
          </c:tx>
          <c:invertIfNegative val="0"/>
          <c:errBars>
            <c:errBarType val="both"/>
            <c:errValType val="stdErr"/>
            <c:noEndCap val="0"/>
          </c:errBars>
          <c:cat>
            <c:strRef>
              <c:f>'[Copy of 6-CYS Vaccine Expt Heba spreadsheet 6-22-16 eggs.xlsx]Egg data'!$E$33:$F$33</c:f>
              <c:strCache>
                <c:ptCount val="2"/>
                <c:pt idx="0">
                  <c:v>Control</c:v>
                </c:pt>
                <c:pt idx="1">
                  <c:v>Vaccinated</c:v>
                </c:pt>
              </c:strCache>
            </c:strRef>
          </c:cat>
          <c:val>
            <c:numRef>
              <c:f>'[Copy of 6-CYS Vaccine Expt Heba spreadsheet 6-22-16 eggs.xlsx]Egg data'!$E$34:$F$34</c:f>
              <c:numCache>
                <c:formatCode>General</c:formatCode>
                <c:ptCount val="2"/>
                <c:pt idx="0">
                  <c:v>0.22438733333333336</c:v>
                </c:pt>
                <c:pt idx="1">
                  <c:v>0.260926666666666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DDD-3746-B9C7-7D8608F88FA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51109504"/>
        <c:axId val="751108960"/>
      </c:barChart>
      <c:catAx>
        <c:axId val="7511095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2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2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Tick source </a:t>
                </a:r>
              </a:p>
            </c:rich>
          </c:tx>
          <c:layout>
            <c:manualLayout>
              <c:xMode val="edge"/>
              <c:yMode val="edge"/>
              <c:x val="0.46148098435088519"/>
              <c:y val="0.86386045961051805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751108960"/>
        <c:crosses val="autoZero"/>
        <c:auto val="1"/>
        <c:lblAlgn val="ctr"/>
        <c:lblOffset val="100"/>
        <c:noMultiLvlLbl val="0"/>
      </c:catAx>
      <c:valAx>
        <c:axId val="75110896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2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Tick weight (gm)</a:t>
                </a:r>
              </a:p>
            </c:rich>
          </c:tx>
          <c:layout>
            <c:manualLayout>
              <c:xMode val="edge"/>
              <c:yMode val="edge"/>
              <c:x val="8.882926507046739E-3"/>
              <c:y val="8.6086869887269379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75110950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116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116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F2FA3D-2F7A-4AA2-95AC-80D01F2A9AF3}" type="datetimeFigureOut">
              <a:rPr lang="en-US" smtClean="0"/>
              <a:t>4/7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692150"/>
            <a:ext cx="4610100" cy="3457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381103"/>
            <a:ext cx="5608320" cy="415051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60606"/>
            <a:ext cx="3037840" cy="46116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760606"/>
            <a:ext cx="3037840" cy="46116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734BAE-C534-479E-A9FC-EAFBA29B50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9362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9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3734BAE-C534-479E-A9FC-EAFBA29B503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1450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xmlns="" id="{B1F34687-02BC-044B-B594-ED1740369DD9}"/>
              </a:ext>
            </a:extLst>
          </p:cNvPr>
          <p:cNvGrpSpPr/>
          <p:nvPr/>
        </p:nvGrpSpPr>
        <p:grpSpPr>
          <a:xfrm>
            <a:off x="469932" y="609600"/>
            <a:ext cx="8260830" cy="5352886"/>
            <a:chOff x="469932" y="609600"/>
            <a:chExt cx="8260830" cy="5352886"/>
          </a:xfrm>
        </p:grpSpPr>
        <p:sp>
          <p:nvSpPr>
            <p:cNvPr id="4" name="Rectangle 3"/>
            <p:cNvSpPr/>
            <p:nvPr/>
          </p:nvSpPr>
          <p:spPr>
            <a:xfrm>
              <a:off x="469932" y="609600"/>
              <a:ext cx="312906" cy="3231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5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graphicFrame>
          <p:nvGraphicFramePr>
            <p:cNvPr id="9" name="Chart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30524986"/>
                </p:ext>
              </p:extLst>
            </p:nvPr>
          </p:nvGraphicFramePr>
          <p:xfrm>
            <a:off x="851557" y="3624650"/>
            <a:ext cx="3754964" cy="227783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10" name="Chart 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63778258"/>
                </p:ext>
              </p:extLst>
            </p:nvPr>
          </p:nvGraphicFramePr>
          <p:xfrm>
            <a:off x="4883477" y="3684649"/>
            <a:ext cx="3847284" cy="227783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1" name="Rectangle 10"/>
            <p:cNvSpPr/>
            <p:nvPr/>
          </p:nvSpPr>
          <p:spPr>
            <a:xfrm>
              <a:off x="533400" y="3324568"/>
              <a:ext cx="312906" cy="3231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5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aphicFrame>
          <p:nvGraphicFramePr>
            <p:cNvPr id="8" name="Chart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51729101"/>
                </p:ext>
              </p:extLst>
            </p:nvPr>
          </p:nvGraphicFramePr>
          <p:xfrm>
            <a:off x="4791160" y="1326424"/>
            <a:ext cx="3939602" cy="219489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13" name="Chart 1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81274901"/>
                </p:ext>
              </p:extLst>
            </p:nvPr>
          </p:nvGraphicFramePr>
          <p:xfrm>
            <a:off x="862639" y="1110339"/>
            <a:ext cx="3928520" cy="251431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xmlns="" id="{C79668DE-AF47-084B-A438-F7D79387A41D}"/>
                </a:ext>
              </a:extLst>
            </p:cNvPr>
            <p:cNvSpPr/>
            <p:nvPr/>
          </p:nvSpPr>
          <p:spPr>
            <a:xfrm>
              <a:off x="3352800" y="2971800"/>
              <a:ext cx="1156747" cy="19650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 anchorCtr="0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400" dirty="0">
                  <a:solidFill>
                    <a:schemeClr val="tx1"/>
                  </a:solidFill>
                </a:rPr>
                <a:t>Immunized</a:t>
              </a:r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xmlns="" id="{C717EE97-F88A-7F43-A81C-AE2257E279E6}"/>
                </a:ext>
              </a:extLst>
            </p:cNvPr>
            <p:cNvSpPr/>
            <p:nvPr/>
          </p:nvSpPr>
          <p:spPr>
            <a:xfrm>
              <a:off x="7301453" y="2895600"/>
              <a:ext cx="1156747" cy="26155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t" anchorCtr="0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400" dirty="0">
                  <a:solidFill>
                    <a:schemeClr val="tx1"/>
                  </a:solidFill>
                </a:rPr>
                <a:t>Immunized</a:t>
              </a: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xmlns="" id="{3C71BE7E-7145-FB41-8679-7C27E16A3248}"/>
                </a:ext>
              </a:extLst>
            </p:cNvPr>
            <p:cNvSpPr/>
            <p:nvPr/>
          </p:nvSpPr>
          <p:spPr>
            <a:xfrm>
              <a:off x="5638800" y="5334000"/>
              <a:ext cx="1731818" cy="3142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t" anchorCtr="0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400" dirty="0">
                  <a:solidFill>
                    <a:schemeClr val="tx1"/>
                  </a:solidFill>
                </a:rPr>
                <a:t>Immunized induced</a:t>
              </a:r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xmlns="" id="{0DE92587-89F3-AC4F-9B8C-189B0A60E0EB}"/>
                </a:ext>
              </a:extLst>
            </p:cNvPr>
            <p:cNvSpPr/>
            <p:nvPr/>
          </p:nvSpPr>
          <p:spPr>
            <a:xfrm>
              <a:off x="1616745" y="5105400"/>
              <a:ext cx="1431255" cy="42505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t" anchorCtr="0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sz="1400" dirty="0">
                  <a:solidFill>
                    <a:schemeClr val="tx1"/>
                  </a:solidFill>
                </a:rPr>
                <a:t>Immunized not induced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7924E846-AD3D-5F4A-B828-59CFA4EC6B18}"/>
              </a:ext>
            </a:extLst>
          </p:cNvPr>
          <p:cNvSpPr txBox="1"/>
          <p:nvPr/>
        </p:nvSpPr>
        <p:spPr>
          <a:xfrm>
            <a:off x="8382000" y="6449786"/>
            <a:ext cx="7328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S8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113316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5642</TotalTime>
  <Words>49</Words>
  <Application>Microsoft Office PowerPoint</Application>
  <PresentationFormat>On-screen Show (4:3)</PresentationFormat>
  <Paragraphs>2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zan, Heba Fathy</dc:creator>
  <cp:lastModifiedBy>Pon Abirami A.</cp:lastModifiedBy>
  <cp:revision>178</cp:revision>
  <dcterms:created xsi:type="dcterms:W3CDTF">2020-04-03T19:59:23Z</dcterms:created>
  <dcterms:modified xsi:type="dcterms:W3CDTF">2021-04-07T08:08:46Z</dcterms:modified>
</cp:coreProperties>
</file>